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6" r:id="rId3"/>
    <p:sldId id="258" r:id="rId4"/>
    <p:sldId id="261" r:id="rId5"/>
    <p:sldId id="260" r:id="rId6"/>
    <p:sldId id="271" r:id="rId7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366" autoAdjust="0"/>
    <p:restoredTop sz="94660"/>
  </p:normalViewPr>
  <p:slideViewPr>
    <p:cSldViewPr>
      <p:cViewPr>
        <p:scale>
          <a:sx n="80" d="100"/>
          <a:sy n="80" d="100"/>
        </p:scale>
        <p:origin x="3078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E8CFF1-8D93-40DF-BBFB-B59E25B53122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927" y="4716661"/>
            <a:ext cx="5439410" cy="446841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342" y="9431599"/>
            <a:ext cx="2946347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611C5F-50AC-455B-9991-C5E95B223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3172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611C5F-50AC-455B-9991-C5E95B22393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1604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611C5F-50AC-455B-9991-C5E95B22393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2176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611C5F-50AC-455B-9991-C5E95B22393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08213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611C5F-50AC-455B-9991-C5E95B22393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0389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611C5F-50AC-455B-9991-C5E95B22393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24263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611C5F-50AC-455B-9991-C5E95B22393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128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762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831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076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562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027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302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955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542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365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239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10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AA05A-70F8-4102-958B-9A393E9F2E8C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9C924-D0DA-4246-8365-1D3A0DF58C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346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2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4.wdp"/><Relationship Id="rId18" Type="http://schemas.openxmlformats.org/officeDocument/2006/relationships/image" Target="../media/image31.png"/><Relationship Id="rId3" Type="http://schemas.openxmlformats.org/officeDocument/2006/relationships/image" Target="../media/image20.jpeg"/><Relationship Id="rId7" Type="http://schemas.openxmlformats.org/officeDocument/2006/relationships/image" Target="../media/image23.png"/><Relationship Id="rId12" Type="http://schemas.openxmlformats.org/officeDocument/2006/relationships/image" Target="../media/image26.png"/><Relationship Id="rId17" Type="http://schemas.openxmlformats.org/officeDocument/2006/relationships/image" Target="../media/image30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29.png"/><Relationship Id="rId20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microsoft.com/office/2007/relationships/hdphoto" Target="../media/hdphoto3.wdp"/><Relationship Id="rId5" Type="http://schemas.openxmlformats.org/officeDocument/2006/relationships/image" Target="../media/image22.png"/><Relationship Id="rId15" Type="http://schemas.openxmlformats.org/officeDocument/2006/relationships/image" Target="../media/image28.png"/><Relationship Id="rId10" Type="http://schemas.openxmlformats.org/officeDocument/2006/relationships/image" Target="../media/image25.png"/><Relationship Id="rId19" Type="http://schemas.openxmlformats.org/officeDocument/2006/relationships/image" Target="../media/image32.png"/><Relationship Id="rId4" Type="http://schemas.openxmlformats.org/officeDocument/2006/relationships/image" Target="../media/image21.jpeg"/><Relationship Id="rId9" Type="http://schemas.openxmlformats.org/officeDocument/2006/relationships/image" Target="../media/image24.png"/><Relationship Id="rId14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116427" y="8768407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Fig. 1 </a:t>
            </a:r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0" y="-28521"/>
            <a:ext cx="6686052" cy="5057721"/>
            <a:chOff x="0" y="-28521"/>
            <a:chExt cx="6686052" cy="5057721"/>
          </a:xfrm>
        </p:grpSpPr>
        <p:grpSp>
          <p:nvGrpSpPr>
            <p:cNvPr id="18" name="Group 17"/>
            <p:cNvGrpSpPr/>
            <p:nvPr/>
          </p:nvGrpSpPr>
          <p:grpSpPr>
            <a:xfrm>
              <a:off x="5650096" y="3696010"/>
              <a:ext cx="771528" cy="905517"/>
              <a:chOff x="4051550" y="1321904"/>
              <a:chExt cx="771528" cy="905517"/>
            </a:xfrm>
          </p:grpSpPr>
          <p:sp>
            <p:nvSpPr>
              <p:cNvPr id="19" name="Rectangle 18"/>
              <p:cNvSpPr/>
              <p:nvPr/>
            </p:nvSpPr>
            <p:spPr>
              <a:xfrm>
                <a:off x="4191000" y="1570951"/>
                <a:ext cx="161049" cy="76200"/>
              </a:xfrm>
              <a:prstGeom prst="rect">
                <a:avLst/>
              </a:prstGeom>
              <a:solidFill>
                <a:srgbClr val="CC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4193126" y="1743947"/>
                <a:ext cx="156797" cy="762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rgbClr val="CCCCFF"/>
                </a:bgClr>
              </a:patt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4191000" y="2075021"/>
                <a:ext cx="161049" cy="762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4191000" y="1916943"/>
                <a:ext cx="161049" cy="762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370710" y="1485940"/>
                <a:ext cx="4523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/>
                  <a:t>0    </a:t>
                </a:r>
                <a:r>
                  <a:rPr lang="sv-SE" sz="1000" dirty="0" smtClean="0"/>
                  <a:t>   </a:t>
                </a:r>
                <a:endParaRPr lang="sv-SE" sz="10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370709" y="1658779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/>
                  <a:t>3</a:t>
                </a:r>
                <a:endParaRPr lang="sv-SE" sz="10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4352049" y="1828800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/>
                  <a:t>15</a:t>
                </a:r>
                <a:endParaRPr lang="sv-SE" sz="10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352049" y="1981200"/>
                <a:ext cx="44595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/>
                  <a:t>15+3</a:t>
                </a:r>
                <a:endParaRPr lang="sv-SE" sz="1000" dirty="0"/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4051550" y="1321904"/>
                <a:ext cx="54854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/>
                  <a:t> </a:t>
                </a:r>
                <a:r>
                  <a:rPr lang="sv-S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DIR </a:t>
                </a:r>
              </a:p>
            </p:txBody>
          </p:sp>
        </p:grpSp>
        <p:sp>
          <p:nvSpPr>
            <p:cNvPr id="2" name="Rectangle 1"/>
            <p:cNvSpPr/>
            <p:nvPr/>
          </p:nvSpPr>
          <p:spPr>
            <a:xfrm>
              <a:off x="4876800" y="4846471"/>
              <a:ext cx="457200" cy="1827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0" y="-28521"/>
              <a:ext cx="6659398" cy="4730199"/>
              <a:chOff x="0" y="0"/>
              <a:chExt cx="6659398" cy="4730199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0" y="0"/>
                <a:ext cx="6659398" cy="4730199"/>
                <a:chOff x="0" y="0"/>
                <a:chExt cx="6659398" cy="4730199"/>
              </a:xfrm>
            </p:grpSpPr>
            <p:pic>
              <p:nvPicPr>
                <p:cNvPr id="4" name="Content Placeholder 4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6746" y="0"/>
                  <a:ext cx="6552652" cy="4677727"/>
                </a:xfrm>
                <a:prstGeom prst="rect">
                  <a:avLst/>
                </a:prstGeom>
                <a:solidFill>
                  <a:schemeClr val="bg1"/>
                </a:solidFill>
              </p:spPr>
            </p:pic>
            <p:sp>
              <p:nvSpPr>
                <p:cNvPr id="8" name="TextBox 7"/>
                <p:cNvSpPr txBox="1"/>
                <p:nvPr/>
              </p:nvSpPr>
              <p:spPr>
                <a:xfrm rot="21114949">
                  <a:off x="2056013" y="2631529"/>
                  <a:ext cx="59663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000" dirty="0" smtClean="0"/>
                    <a:t>Passage</a:t>
                  </a:r>
                  <a:endParaRPr lang="en-US" sz="1000" dirty="0"/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 rot="21114949">
                  <a:off x="2147949" y="4056450"/>
                  <a:ext cx="59663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000" dirty="0" smtClean="0"/>
                    <a:t>Passage</a:t>
                  </a:r>
                  <a:endParaRPr lang="en-US" sz="1000" dirty="0"/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1604257" y="4301249"/>
                  <a:ext cx="28565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000" dirty="0" smtClean="0"/>
                    <a:t>IR</a:t>
                  </a:r>
                  <a:endParaRPr lang="en-US" sz="1000" dirty="0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4083270" y="2971800"/>
                  <a:ext cx="28565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000" dirty="0" smtClean="0"/>
                    <a:t>IR</a:t>
                  </a:r>
                  <a:endParaRPr lang="en-US" sz="1000" dirty="0"/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4156342" y="4220289"/>
                  <a:ext cx="28565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000" dirty="0" smtClean="0"/>
                    <a:t>IR</a:t>
                  </a:r>
                  <a:endParaRPr lang="en-US" sz="1000" dirty="0"/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0" y="0"/>
                  <a:ext cx="1045641" cy="1524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8" name="Rectangle 27"/>
                <p:cNvSpPr/>
                <p:nvPr/>
              </p:nvSpPr>
              <p:spPr>
                <a:xfrm>
                  <a:off x="173559" y="2286000"/>
                  <a:ext cx="1045641" cy="1524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0" y="2221468"/>
                  <a:ext cx="309700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sv-SE" dirty="0"/>
                    <a:t>B</a:t>
                  </a:r>
                  <a:endParaRPr lang="en-US" dirty="0"/>
                </a:p>
              </p:txBody>
            </p:sp>
            <p:sp>
              <p:nvSpPr>
                <p:cNvPr id="31" name="Rectangle 30"/>
                <p:cNvSpPr/>
                <p:nvPr/>
              </p:nvSpPr>
              <p:spPr>
                <a:xfrm>
                  <a:off x="5791200" y="2555634"/>
                  <a:ext cx="868198" cy="217456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0" y="0"/>
                  <a:ext cx="31771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dirty="0" smtClean="0"/>
                    <a:t>A</a:t>
                  </a:r>
                  <a:endParaRPr lang="en-US" dirty="0"/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2041664" y="3177236"/>
                  <a:ext cx="28565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v-SE" sz="1000" dirty="0" smtClean="0"/>
                    <a:t>IR</a:t>
                  </a:r>
                  <a:endParaRPr lang="en-US" sz="1000" dirty="0"/>
                </a:p>
              </p:txBody>
            </p:sp>
          </p:grpSp>
          <p:sp>
            <p:nvSpPr>
              <p:cNvPr id="5" name="TextBox 4"/>
              <p:cNvSpPr txBox="1"/>
              <p:nvPr/>
            </p:nvSpPr>
            <p:spPr>
              <a:xfrm>
                <a:off x="207958" y="248960"/>
                <a:ext cx="1282723" cy="86177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tients:</a:t>
                </a:r>
              </a:p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ediatric glioma</a:t>
                </a:r>
              </a:p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HO grade lV</a:t>
                </a:r>
              </a:p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=5</a:t>
                </a:r>
              </a:p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adiotherapy 54Gy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0" name="TextBox 49"/>
            <p:cNvSpPr txBox="1"/>
            <p:nvPr/>
          </p:nvSpPr>
          <p:spPr>
            <a:xfrm>
              <a:off x="192629" y="1181161"/>
              <a:ext cx="1636172" cy="86177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 cultures:</a:t>
              </a:r>
            </a:p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stablished and cultured </a:t>
              </a:r>
            </a:p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 stem cell media</a:t>
              </a:r>
            </a:p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</a:p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Wenger et al 2017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5" name="Content Placeholder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550" t="4467" r="28262" b="61545"/>
            <a:stretch/>
          </p:blipFill>
          <p:spPr>
            <a:xfrm>
              <a:off x="5418239" y="2848716"/>
              <a:ext cx="1199374" cy="140429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grpSp>
          <p:nvGrpSpPr>
            <p:cNvPr id="66" name="Group 65"/>
            <p:cNvGrpSpPr/>
            <p:nvPr/>
          </p:nvGrpSpPr>
          <p:grpSpPr>
            <a:xfrm>
              <a:off x="5847361" y="2868392"/>
              <a:ext cx="838691" cy="1197760"/>
              <a:chOff x="4876800" y="1545440"/>
              <a:chExt cx="838691" cy="1197760"/>
            </a:xfrm>
            <a:solidFill>
              <a:schemeClr val="bg1"/>
            </a:solidFill>
          </p:grpSpPr>
          <p:sp>
            <p:nvSpPr>
              <p:cNvPr id="67" name="Rectangle 66"/>
              <p:cNvSpPr/>
              <p:nvPr/>
            </p:nvSpPr>
            <p:spPr>
              <a:xfrm>
                <a:off x="4876800" y="1783325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10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4876800" y="2021210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15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4876800" y="2259095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19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4876800" y="1545440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U-pBT-07</a:t>
                </a: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4876800" y="2496979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28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4720068" y="4554379"/>
              <a:ext cx="74571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sv-S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+3 FDIR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6505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6427" y="381000"/>
            <a:ext cx="6932073" cy="8756739"/>
            <a:chOff x="116427" y="381000"/>
            <a:chExt cx="6932073" cy="8756739"/>
          </a:xfrm>
        </p:grpSpPr>
        <p:grpSp>
          <p:nvGrpSpPr>
            <p:cNvPr id="2" name="Group 1"/>
            <p:cNvGrpSpPr/>
            <p:nvPr/>
          </p:nvGrpSpPr>
          <p:grpSpPr>
            <a:xfrm>
              <a:off x="609600" y="381000"/>
              <a:ext cx="5257800" cy="6324600"/>
              <a:chOff x="609600" y="381000"/>
              <a:chExt cx="5257800" cy="6324600"/>
            </a:xfrm>
          </p:grpSpPr>
          <p:pic>
            <p:nvPicPr>
              <p:cNvPr id="5" name="Content Placeholder 8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5099" y="677868"/>
                <a:ext cx="4842301" cy="6027732"/>
              </a:xfrm>
              <a:prstGeom prst="rect">
                <a:avLst/>
              </a:prstGeom>
            </p:spPr>
          </p:pic>
          <p:sp>
            <p:nvSpPr>
              <p:cNvPr id="6" name="Rectangle 5"/>
              <p:cNvSpPr/>
              <p:nvPr/>
            </p:nvSpPr>
            <p:spPr>
              <a:xfrm>
                <a:off x="609600" y="381000"/>
                <a:ext cx="505484" cy="59758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676400" y="515779"/>
                <a:ext cx="68580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Gy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113887" y="485001"/>
                <a:ext cx="99060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 smtClean="0"/>
                  <a:t> 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 Gy </a:t>
                </a:r>
                <a:endParaRPr 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800600" y="515779"/>
                <a:ext cx="68580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Gy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713716" y="752117"/>
                <a:ext cx="369332" cy="10653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rtlCol="0">
                <a:spAutoFit/>
              </a:bodyPr>
              <a:lstStyle/>
              <a:p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U−pBT−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7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713716" y="1931373"/>
                <a:ext cx="369332" cy="1029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rtlCol="0">
                <a:spAutoFit/>
              </a:bodyPr>
              <a:lstStyle/>
              <a:p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−</a:t>
                </a:r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BT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−15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13716" y="3117591"/>
                <a:ext cx="369332" cy="106203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rtlCol="0">
                <a:spAutoFit/>
              </a:bodyPr>
              <a:lstStyle/>
              <a:p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U−pBT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−19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713716" y="4329647"/>
                <a:ext cx="369332" cy="106918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rtlCol="0">
                <a:spAutoFit/>
              </a:bodyPr>
              <a:lstStyle/>
              <a:p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U−pBT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−28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713716" y="5486400"/>
                <a:ext cx="369332" cy="10668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rtlCol="0">
                <a:spAutoFit/>
              </a:bodyPr>
              <a:lstStyle/>
              <a:p>
                <a:r>
                  <a:rPr lang="sv-S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U−pBT</a:t>
                </a:r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−10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5309234" y="6459379"/>
                <a:ext cx="55816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solidFill>
                      <a:schemeClr val="bg1"/>
                    </a:solidFill>
                    <a:latin typeface="Symbol" panose="05050102010706020507" pitchFamily="18" charset="2"/>
                  </a:rPr>
                  <a:t>100m</a:t>
                </a:r>
                <a:r>
                  <a:rPr lang="en-US" sz="10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en-US" sz="1000" dirty="0">
                  <a:solidFill>
                    <a:schemeClr val="bg1"/>
                  </a:solidFill>
                  <a:latin typeface="Symbol" panose="05050102010706020507" pitchFamily="18" charset="2"/>
                </a:endParaRPr>
              </a:p>
            </p:txBody>
          </p:sp>
          <p:cxnSp>
            <p:nvCxnSpPr>
              <p:cNvPr id="39" name="Straight Connector 38"/>
              <p:cNvCxnSpPr/>
              <p:nvPr/>
            </p:nvCxnSpPr>
            <p:spPr>
              <a:xfrm>
                <a:off x="5424412" y="6509266"/>
                <a:ext cx="224292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1227706" y="797610"/>
                <a:ext cx="2743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b="1" dirty="0" smtClean="0">
                    <a:solidFill>
                      <a:schemeClr val="accent1"/>
                    </a:solidFill>
                  </a:rPr>
                  <a:t>DAPI</a:t>
                </a:r>
                <a:r>
                  <a:rPr lang="sv-SE" sz="1200" b="1" dirty="0" smtClean="0">
                    <a:solidFill>
                      <a:srgbClr val="92D050"/>
                    </a:solidFill>
                  </a:rPr>
                  <a:t>/EDU/</a:t>
                </a:r>
                <a:r>
                  <a:rPr lang="el-GR" sz="1200" b="1" dirty="0" smtClean="0">
                    <a:solidFill>
                      <a:srgbClr val="92D050"/>
                    </a:solidFill>
                  </a:rPr>
                  <a:t> </a:t>
                </a:r>
                <a:r>
                  <a:rPr lang="el-GR" sz="1200" b="1" dirty="0" smtClean="0">
                    <a:solidFill>
                      <a:schemeClr val="accent6"/>
                    </a:solidFill>
                  </a:rPr>
                  <a:t>α-</a:t>
                </a:r>
                <a:r>
                  <a:rPr lang="sv-SE" sz="1200" b="1" dirty="0" err="1" smtClean="0">
                    <a:solidFill>
                      <a:schemeClr val="accent6"/>
                    </a:solidFill>
                  </a:rPr>
                  <a:t>Tubulin</a:t>
                </a:r>
                <a:r>
                  <a:rPr lang="sv-SE" sz="1200" b="1" dirty="0" smtClean="0">
                    <a:solidFill>
                      <a:schemeClr val="accent6"/>
                    </a:solidFill>
                  </a:rPr>
                  <a:t> </a:t>
                </a:r>
                <a:endParaRPr lang="en-US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2743200" y="797611"/>
                <a:ext cx="2743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b="1" dirty="0" smtClean="0">
                    <a:solidFill>
                      <a:schemeClr val="accent1"/>
                    </a:solidFill>
                  </a:rPr>
                  <a:t>DAPI</a:t>
                </a:r>
                <a:r>
                  <a:rPr lang="sv-SE" sz="1200" b="1" dirty="0" smtClean="0">
                    <a:solidFill>
                      <a:srgbClr val="92D050"/>
                    </a:solidFill>
                  </a:rPr>
                  <a:t>/EDU/</a:t>
                </a:r>
                <a:r>
                  <a:rPr lang="el-GR" sz="1200" b="1" dirty="0" smtClean="0">
                    <a:solidFill>
                      <a:srgbClr val="92D050"/>
                    </a:solidFill>
                  </a:rPr>
                  <a:t> </a:t>
                </a:r>
                <a:r>
                  <a:rPr lang="el-GR" sz="1200" b="1" dirty="0" smtClean="0">
                    <a:solidFill>
                      <a:schemeClr val="accent6"/>
                    </a:solidFill>
                  </a:rPr>
                  <a:t>α-</a:t>
                </a:r>
                <a:r>
                  <a:rPr lang="sv-SE" sz="1200" b="1" dirty="0" err="1" smtClean="0">
                    <a:solidFill>
                      <a:schemeClr val="accent6"/>
                    </a:solidFill>
                  </a:rPr>
                  <a:t>Tubulin</a:t>
                </a:r>
                <a:r>
                  <a:rPr lang="sv-SE" sz="1200" b="1" dirty="0" smtClean="0">
                    <a:solidFill>
                      <a:schemeClr val="accent6"/>
                    </a:solidFill>
                  </a:rPr>
                  <a:t> </a:t>
                </a:r>
                <a:endParaRPr lang="en-US" b="1" dirty="0">
                  <a:solidFill>
                    <a:schemeClr val="accent6"/>
                  </a:solidFill>
                </a:endParaRPr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4305300" y="816367"/>
              <a:ext cx="2743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b="1" dirty="0" smtClean="0">
                  <a:solidFill>
                    <a:schemeClr val="accent1"/>
                  </a:solidFill>
                </a:rPr>
                <a:t>DAPI</a:t>
              </a:r>
              <a:r>
                <a:rPr lang="sv-SE" sz="1200" b="1" dirty="0" smtClean="0">
                  <a:solidFill>
                    <a:srgbClr val="92D050"/>
                  </a:solidFill>
                </a:rPr>
                <a:t>/EDU/</a:t>
              </a:r>
              <a:r>
                <a:rPr lang="el-GR" sz="1200" b="1" dirty="0" smtClean="0">
                  <a:solidFill>
                    <a:srgbClr val="92D050"/>
                  </a:solidFill>
                </a:rPr>
                <a:t> </a:t>
              </a:r>
              <a:r>
                <a:rPr lang="el-GR" sz="1200" b="1" dirty="0" smtClean="0">
                  <a:solidFill>
                    <a:schemeClr val="accent6"/>
                  </a:solidFill>
                </a:rPr>
                <a:t>α-</a:t>
              </a:r>
              <a:r>
                <a:rPr lang="sv-SE" sz="1200" b="1" dirty="0" err="1" smtClean="0">
                  <a:solidFill>
                    <a:schemeClr val="accent6"/>
                  </a:solidFill>
                </a:rPr>
                <a:t>Tubulin</a:t>
              </a:r>
              <a:r>
                <a:rPr lang="sv-SE" sz="1200" b="1" dirty="0" smtClean="0">
                  <a:solidFill>
                    <a:schemeClr val="accent6"/>
                  </a:solidFill>
                </a:rPr>
                <a:t> </a:t>
              </a:r>
              <a:endParaRPr lang="en-US" b="1" dirty="0">
                <a:solidFill>
                  <a:schemeClr val="accent6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16427" y="8768407"/>
              <a:ext cx="7328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 smtClean="0"/>
                <a:t>Fig. 2 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4829671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83910" y="191895"/>
            <a:ext cx="7278129" cy="8945844"/>
            <a:chOff x="-83910" y="191895"/>
            <a:chExt cx="7278129" cy="8945844"/>
          </a:xfrm>
        </p:grpSpPr>
        <p:sp>
          <p:nvSpPr>
            <p:cNvPr id="18" name="Rectangle 17"/>
            <p:cNvSpPr/>
            <p:nvPr/>
          </p:nvSpPr>
          <p:spPr>
            <a:xfrm>
              <a:off x="2462641" y="5901764"/>
              <a:ext cx="21352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1000" dirty="0" smtClean="0"/>
                <a:t> </a:t>
              </a:r>
              <a:endParaRPr lang="sv-SE" sz="1000" dirty="0"/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5488129" y="8282868"/>
              <a:ext cx="1706090" cy="532373"/>
              <a:chOff x="1791604" y="3380687"/>
              <a:chExt cx="1706090" cy="532373"/>
            </a:xfrm>
          </p:grpSpPr>
          <p:sp>
            <p:nvSpPr>
              <p:cNvPr id="35" name="Rectangle 34"/>
              <p:cNvSpPr/>
              <p:nvPr/>
            </p:nvSpPr>
            <p:spPr>
              <a:xfrm>
                <a:off x="1791604" y="3473799"/>
                <a:ext cx="161049" cy="60112"/>
              </a:xfrm>
              <a:prstGeom prst="rect">
                <a:avLst/>
              </a:prstGeom>
              <a:solidFill>
                <a:srgbClr val="CC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971314" y="3380687"/>
                <a:ext cx="15263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07 0 FDIR       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971313" y="3512950"/>
                <a:ext cx="148149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U-pBT-07 </a:t>
                </a:r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 </a:t>
                </a:r>
                <a:r>
                  <a:rPr lang="sv-S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DIR</a:t>
                </a:r>
                <a:r>
                  <a:rPr lang="sv-SE" sz="1000" dirty="0"/>
                  <a:t>       </a:t>
                </a:r>
              </a:p>
              <a:p>
                <a:endParaRPr lang="sv-SE" sz="1000" dirty="0"/>
              </a:p>
            </p:txBody>
          </p:sp>
          <p:sp>
            <p:nvSpPr>
              <p:cNvPr id="38" name="Rectangle 37"/>
              <p:cNvSpPr/>
              <p:nvPr/>
            </p:nvSpPr>
            <p:spPr>
              <a:xfrm flipV="1">
                <a:off x="1793730" y="3601537"/>
                <a:ext cx="156797" cy="56063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116427" y="8768407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 smtClean="0"/>
                <a:t>Fig. 3</a:t>
              </a:r>
              <a:endParaRPr lang="en-US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11360" y="6221770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D</a:t>
              </a:r>
              <a:endParaRPr lang="en-US" dirty="0"/>
            </a:p>
          </p:txBody>
        </p:sp>
        <p:pic>
          <p:nvPicPr>
            <p:cNvPr id="42" name="Content Placeholder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550" t="4467" r="28262" b="61545"/>
            <a:stretch/>
          </p:blipFill>
          <p:spPr>
            <a:xfrm>
              <a:off x="4447678" y="1525764"/>
              <a:ext cx="1199374" cy="140429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grpSp>
          <p:nvGrpSpPr>
            <p:cNvPr id="43" name="Group 42"/>
            <p:cNvGrpSpPr/>
            <p:nvPr/>
          </p:nvGrpSpPr>
          <p:grpSpPr>
            <a:xfrm>
              <a:off x="5805821" y="1537648"/>
              <a:ext cx="1035176" cy="532373"/>
              <a:chOff x="1791604" y="3380687"/>
              <a:chExt cx="1035176" cy="532373"/>
            </a:xfrm>
          </p:grpSpPr>
          <p:sp>
            <p:nvSpPr>
              <p:cNvPr id="44" name="Rectangle 43"/>
              <p:cNvSpPr/>
              <p:nvPr/>
            </p:nvSpPr>
            <p:spPr>
              <a:xfrm>
                <a:off x="1791604" y="3473799"/>
                <a:ext cx="161049" cy="60112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989691" y="3380687"/>
                <a:ext cx="8370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FDIR       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989691" y="3512950"/>
                <a:ext cx="62549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 FDIR </a:t>
                </a:r>
              </a:p>
              <a:p>
                <a:endParaRPr lang="sv-SE" sz="1000" dirty="0"/>
              </a:p>
            </p:txBody>
          </p:sp>
          <p:sp>
            <p:nvSpPr>
              <p:cNvPr id="47" name="Rectangle 46"/>
              <p:cNvSpPr/>
              <p:nvPr/>
            </p:nvSpPr>
            <p:spPr>
              <a:xfrm flipV="1">
                <a:off x="1793730" y="3601537"/>
                <a:ext cx="156797" cy="56063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0" name="Rectangle 9"/>
            <p:cNvSpPr/>
            <p:nvPr/>
          </p:nvSpPr>
          <p:spPr>
            <a:xfrm>
              <a:off x="563881" y="4038600"/>
              <a:ext cx="45719" cy="2005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563881" y="4672374"/>
              <a:ext cx="45719" cy="2005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-83910" y="709553"/>
              <a:ext cx="4058410" cy="2361036"/>
              <a:chOff x="-228600" y="709553"/>
              <a:chExt cx="4058410" cy="2361036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743" r="301"/>
              <a:stretch/>
            </p:blipFill>
            <p:spPr>
              <a:xfrm>
                <a:off x="-228600" y="762000"/>
                <a:ext cx="4058410" cy="2308589"/>
              </a:xfrm>
              <a:prstGeom prst="rect">
                <a:avLst/>
              </a:prstGeom>
            </p:spPr>
          </p:pic>
          <p:sp>
            <p:nvSpPr>
              <p:cNvPr id="54" name="Rectangle 53"/>
              <p:cNvSpPr/>
              <p:nvPr/>
            </p:nvSpPr>
            <p:spPr>
              <a:xfrm rot="16200000">
                <a:off x="-707848" y="1587877"/>
                <a:ext cx="203364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sv-SE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uclidean distance metric</a:t>
                </a:r>
                <a:endParaRPr lang="sv-SE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259916" y="5870285"/>
              <a:ext cx="2900960" cy="2881349"/>
              <a:chOff x="259916" y="5870285"/>
              <a:chExt cx="2900960" cy="2881349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259916" y="5870285"/>
                <a:ext cx="2900960" cy="2881349"/>
                <a:chOff x="259916" y="5870285"/>
                <a:chExt cx="2900960" cy="2881349"/>
              </a:xfrm>
            </p:grpSpPr>
            <p:pic>
              <p:nvPicPr>
                <p:cNvPr id="39" name="Content Placeholder 4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4648"/>
                <a:stretch/>
              </p:blipFill>
              <p:spPr>
                <a:xfrm>
                  <a:off x="636200" y="6147985"/>
                  <a:ext cx="2331511" cy="2467201"/>
                </a:xfrm>
                <a:prstGeom prst="rect">
                  <a:avLst/>
                </a:prstGeom>
              </p:spPr>
            </p:pic>
            <p:sp>
              <p:nvSpPr>
                <p:cNvPr id="7" name="Rectangle 6"/>
                <p:cNvSpPr/>
                <p:nvPr/>
              </p:nvSpPr>
              <p:spPr>
                <a:xfrm rot="18825969">
                  <a:off x="232102" y="6351610"/>
                  <a:ext cx="1208871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>
                  <a:spAutoFit/>
                </a:bodyPr>
                <a:lstStyle/>
                <a:p>
                  <a:r>
                    <a:rPr lang="sv-SE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U-pBT-07</a:t>
                  </a:r>
                  <a:r>
                    <a:rPr lang="sv-SE" sz="1000" dirty="0" smtClean="0"/>
                    <a:t>       </a:t>
                  </a:r>
                  <a:endParaRPr lang="sv-SE" sz="1000" dirty="0"/>
                </a:p>
              </p:txBody>
            </p:sp>
            <p:sp>
              <p:nvSpPr>
                <p:cNvPr id="33" name="Rectangle 32"/>
                <p:cNvSpPr/>
                <p:nvPr/>
              </p:nvSpPr>
              <p:spPr>
                <a:xfrm rot="1519535">
                  <a:off x="1750983" y="5974100"/>
                  <a:ext cx="938129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>
                  <a:spAutoFit/>
                </a:bodyPr>
                <a:lstStyle/>
                <a:p>
                  <a:r>
                    <a:rPr lang="sv-SE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U-pBT-10</a:t>
                  </a:r>
                  <a:r>
                    <a:rPr lang="sv-SE" dirty="0" smtClean="0"/>
                    <a:t>       </a:t>
                  </a:r>
                  <a:endParaRPr lang="sv-SE" dirty="0"/>
                </a:p>
              </p:txBody>
            </p:sp>
            <p:sp>
              <p:nvSpPr>
                <p:cNvPr id="48" name="Rectangle 47"/>
                <p:cNvSpPr/>
                <p:nvPr/>
              </p:nvSpPr>
              <p:spPr>
                <a:xfrm rot="5400000">
                  <a:off x="2485427" y="7236458"/>
                  <a:ext cx="981565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>
                  <a:spAutoFit/>
                </a:bodyPr>
                <a:lstStyle/>
                <a:p>
                  <a:r>
                    <a:rPr lang="sv-SE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U-pBT-15</a:t>
                  </a:r>
                  <a:r>
                    <a:rPr lang="sv-SE" dirty="0" smtClean="0"/>
                    <a:t>       </a:t>
                  </a:r>
                  <a:endParaRPr lang="sv-SE" dirty="0"/>
                </a:p>
              </p:txBody>
            </p:sp>
            <p:sp>
              <p:nvSpPr>
                <p:cNvPr id="49" name="Rectangle 48"/>
                <p:cNvSpPr/>
                <p:nvPr/>
              </p:nvSpPr>
              <p:spPr>
                <a:xfrm rot="19992082">
                  <a:off x="1988962" y="8382302"/>
                  <a:ext cx="981565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>
                  <a:spAutoFit/>
                </a:bodyPr>
                <a:lstStyle/>
                <a:p>
                  <a:r>
                    <a:rPr lang="sv-SE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U-pBT-19 </a:t>
                  </a:r>
                  <a:r>
                    <a:rPr lang="sv-SE" dirty="0" smtClean="0"/>
                    <a:t>      </a:t>
                  </a:r>
                  <a:endParaRPr lang="sv-SE" dirty="0"/>
                </a:p>
              </p:txBody>
            </p:sp>
            <p:sp>
              <p:nvSpPr>
                <p:cNvPr id="50" name="Rectangle 49"/>
                <p:cNvSpPr/>
                <p:nvPr/>
              </p:nvSpPr>
              <p:spPr>
                <a:xfrm rot="2693407">
                  <a:off x="259916" y="8178056"/>
                  <a:ext cx="1004170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>
                  <a:spAutoFit/>
                </a:bodyPr>
                <a:lstStyle/>
                <a:p>
                  <a:r>
                    <a:rPr lang="sv-SE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U-pBT-28</a:t>
                  </a:r>
                  <a:r>
                    <a:rPr lang="sv-SE" dirty="0" smtClean="0"/>
                    <a:t>    </a:t>
                  </a:r>
                  <a:endParaRPr lang="sv-SE" dirty="0"/>
                </a:p>
              </p:txBody>
            </p:sp>
          </p:grpSp>
          <p:sp>
            <p:nvSpPr>
              <p:cNvPr id="11" name="Rectangle 10"/>
              <p:cNvSpPr/>
              <p:nvPr/>
            </p:nvSpPr>
            <p:spPr>
              <a:xfrm>
                <a:off x="2676161" y="6052340"/>
                <a:ext cx="476215" cy="69357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3362964" y="3124200"/>
              <a:ext cx="3311883" cy="5218186"/>
              <a:chOff x="3362964" y="3124200"/>
              <a:chExt cx="3311883" cy="5218186"/>
            </a:xfrm>
            <a:solidFill>
              <a:schemeClr val="bg1"/>
            </a:solidFill>
          </p:grpSpPr>
          <p:grpSp>
            <p:nvGrpSpPr>
              <p:cNvPr id="19" name="Group 18"/>
              <p:cNvGrpSpPr/>
              <p:nvPr/>
            </p:nvGrpSpPr>
            <p:grpSpPr>
              <a:xfrm>
                <a:off x="3362964" y="3124200"/>
                <a:ext cx="3311883" cy="5218186"/>
                <a:chOff x="152400" y="2739944"/>
                <a:chExt cx="3427587" cy="4935625"/>
              </a:xfrm>
              <a:grpFill/>
            </p:grpSpPr>
            <p:sp>
              <p:nvSpPr>
                <p:cNvPr id="21" name="TextBox 20"/>
                <p:cNvSpPr txBox="1"/>
                <p:nvPr/>
              </p:nvSpPr>
              <p:spPr>
                <a:xfrm>
                  <a:off x="152400" y="2739944"/>
                  <a:ext cx="318862" cy="349333"/>
                </a:xfrm>
                <a:prstGeom prst="rect">
                  <a:avLst/>
                </a:prstGeom>
                <a:grpFill/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sv-SE" dirty="0"/>
                    <a:t>C</a:t>
                  </a:r>
                  <a:endParaRPr 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152400" y="5647525"/>
                  <a:ext cx="307248" cy="349333"/>
                </a:xfrm>
                <a:prstGeom prst="rect">
                  <a:avLst/>
                </a:prstGeom>
                <a:grpFill/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sv-SE" dirty="0"/>
                    <a:t>E</a:t>
                  </a:r>
                  <a:endParaRPr lang="en-US" dirty="0"/>
                </a:p>
              </p:txBody>
            </p:sp>
            <p:grpSp>
              <p:nvGrpSpPr>
                <p:cNvPr id="23" name="Group 22"/>
                <p:cNvGrpSpPr/>
                <p:nvPr/>
              </p:nvGrpSpPr>
              <p:grpSpPr>
                <a:xfrm>
                  <a:off x="635556" y="2895600"/>
                  <a:ext cx="2944431" cy="4779969"/>
                  <a:chOff x="635556" y="2895600"/>
                  <a:chExt cx="2944431" cy="4779969"/>
                </a:xfrm>
                <a:grpFill/>
              </p:grpSpPr>
              <p:pic>
                <p:nvPicPr>
                  <p:cNvPr id="24" name="Picture 23"/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24645"/>
                  <a:stretch/>
                </p:blipFill>
                <p:spPr>
                  <a:xfrm>
                    <a:off x="635556" y="5647525"/>
                    <a:ext cx="2944431" cy="2028044"/>
                  </a:xfrm>
                  <a:prstGeom prst="rect">
                    <a:avLst/>
                  </a:prstGeom>
                  <a:grpFill/>
                  <a:ln>
                    <a:solidFill>
                      <a:schemeClr val="bg1"/>
                    </a:solidFill>
                  </a:ln>
                </p:spPr>
              </p:pic>
              <p:pic>
                <p:nvPicPr>
                  <p:cNvPr id="25" name="Content Placeholder 15"/>
                  <p:cNvPicPr>
                    <a:picLocks noChangeAspect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24165"/>
                  <a:stretch/>
                </p:blipFill>
                <p:spPr>
                  <a:xfrm>
                    <a:off x="710342" y="3356834"/>
                    <a:ext cx="2869645" cy="1754868"/>
                  </a:xfrm>
                  <a:prstGeom prst="rect">
                    <a:avLst/>
                  </a:prstGeom>
                  <a:grpFill/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28" name="Rectangle 27"/>
                  <p:cNvSpPr/>
                  <p:nvPr/>
                </p:nvSpPr>
                <p:spPr>
                  <a:xfrm>
                    <a:off x="2646218" y="2895600"/>
                    <a:ext cx="630382" cy="687200"/>
                  </a:xfrm>
                  <a:prstGeom prst="rect">
                    <a:avLst/>
                  </a:prstGeom>
                  <a:grpFill/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56" name="Rectangle 55"/>
              <p:cNvSpPr/>
              <p:nvPr/>
            </p:nvSpPr>
            <p:spPr>
              <a:xfrm rot="16200000">
                <a:off x="3184115" y="7326715"/>
                <a:ext cx="1681170" cy="276999"/>
              </a:xfrm>
              <a:prstGeom prst="rect">
                <a:avLst/>
              </a:prstGeom>
              <a:grpFill/>
              <a:ln>
                <a:solidFill>
                  <a:schemeClr val="bg1"/>
                </a:solidFill>
              </a:ln>
            </p:spPr>
            <p:txBody>
              <a:bodyPr wrap="square">
                <a:spAutoFit/>
              </a:bodyPr>
              <a:lstStyle/>
              <a:p>
                <a:r>
                  <a:rPr lang="sv-SE" sz="1200" dirty="0" smtClean="0"/>
                  <a:t>Methylation beta value </a:t>
                </a:r>
                <a:endParaRPr lang="sv-SE" sz="1100" dirty="0"/>
              </a:p>
            </p:txBody>
          </p:sp>
        </p:grpSp>
        <p:sp>
          <p:nvSpPr>
            <p:cNvPr id="52" name="Rectangle 51"/>
            <p:cNvSpPr/>
            <p:nvPr/>
          </p:nvSpPr>
          <p:spPr>
            <a:xfrm rot="16200000">
              <a:off x="2788275" y="4168515"/>
              <a:ext cx="2472852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fferentially  methylated sites </a:t>
              </a:r>
              <a:endParaRPr lang="sv-S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Group 59"/>
            <p:cNvGrpSpPr/>
            <p:nvPr/>
          </p:nvGrpSpPr>
          <p:grpSpPr>
            <a:xfrm>
              <a:off x="-5709" y="191895"/>
              <a:ext cx="3047079" cy="5614225"/>
              <a:chOff x="-5709" y="191895"/>
              <a:chExt cx="3047079" cy="5614225"/>
            </a:xfrm>
          </p:grpSpPr>
          <p:grpSp>
            <p:nvGrpSpPr>
              <p:cNvPr id="27" name="Group 26"/>
              <p:cNvGrpSpPr/>
              <p:nvPr/>
            </p:nvGrpSpPr>
            <p:grpSpPr>
              <a:xfrm>
                <a:off x="-5709" y="191895"/>
                <a:ext cx="3047079" cy="5614225"/>
                <a:chOff x="-5709" y="191895"/>
                <a:chExt cx="3047079" cy="5614225"/>
              </a:xfrm>
            </p:grpSpPr>
            <p:grpSp>
              <p:nvGrpSpPr>
                <p:cNvPr id="26" name="Group 25"/>
                <p:cNvGrpSpPr/>
                <p:nvPr/>
              </p:nvGrpSpPr>
              <p:grpSpPr>
                <a:xfrm>
                  <a:off x="-5709" y="191895"/>
                  <a:ext cx="3047079" cy="5614225"/>
                  <a:chOff x="-5709" y="191895"/>
                  <a:chExt cx="3047079" cy="5614225"/>
                </a:xfrm>
              </p:grpSpPr>
              <p:grpSp>
                <p:nvGrpSpPr>
                  <p:cNvPr id="13" name="Group 12"/>
                  <p:cNvGrpSpPr/>
                  <p:nvPr/>
                </p:nvGrpSpPr>
                <p:grpSpPr>
                  <a:xfrm>
                    <a:off x="-5709" y="191895"/>
                    <a:ext cx="3047079" cy="5614225"/>
                    <a:chOff x="-5709" y="191895"/>
                    <a:chExt cx="3047079" cy="5614225"/>
                  </a:xfrm>
                </p:grpSpPr>
                <p:grpSp>
                  <p:nvGrpSpPr>
                    <p:cNvPr id="2" name="Group 1"/>
                    <p:cNvGrpSpPr/>
                    <p:nvPr/>
                  </p:nvGrpSpPr>
                  <p:grpSpPr>
                    <a:xfrm>
                      <a:off x="-5709" y="191895"/>
                      <a:ext cx="3047079" cy="5614225"/>
                      <a:chOff x="4609232" y="611549"/>
                      <a:chExt cx="4070933" cy="5891885"/>
                    </a:xfrm>
                  </p:grpSpPr>
                  <p:pic>
                    <p:nvPicPr>
                      <p:cNvPr id="4" name="Content Placeholder 4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r="22564"/>
                      <a:stretch/>
                    </p:blipFill>
                    <p:spPr>
                      <a:xfrm>
                        <a:off x="5139781" y="4080269"/>
                        <a:ext cx="3540384" cy="2423165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" name="TextBox 7"/>
                      <p:cNvSpPr txBox="1"/>
                      <p:nvPr/>
                    </p:nvSpPr>
                    <p:spPr>
                      <a:xfrm>
                        <a:off x="4918932" y="611549"/>
                        <a:ext cx="317716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sv-SE" dirty="0" smtClean="0"/>
                          <a:t>A</a:t>
                        </a:r>
                        <a:endParaRPr lang="en-US" dirty="0"/>
                      </a:p>
                    </p:txBody>
                  </p:sp>
                  <p:sp>
                    <p:nvSpPr>
                      <p:cNvPr id="9" name="TextBox 8"/>
                      <p:cNvSpPr txBox="1"/>
                      <p:nvPr/>
                    </p:nvSpPr>
                    <p:spPr>
                      <a:xfrm>
                        <a:off x="4609232" y="3720341"/>
                        <a:ext cx="30970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sv-SE" dirty="0"/>
                          <a:t>B</a:t>
                        </a:r>
                        <a:endParaRPr lang="en-US" dirty="0"/>
                      </a:p>
                    </p:txBody>
                  </p:sp>
                </p:grpSp>
                <p:sp>
                  <p:nvSpPr>
                    <p:cNvPr id="51" name="Rectangle 50"/>
                    <p:cNvSpPr/>
                    <p:nvPr/>
                  </p:nvSpPr>
                  <p:spPr>
                    <a:xfrm rot="16200000">
                      <a:off x="-309068" y="4567730"/>
                      <a:ext cx="1560338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sv-S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ion age</a:t>
                      </a:r>
                      <a:endParaRPr lang="sv-SE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0" name="Rectangle 19"/>
                  <p:cNvSpPr/>
                  <p:nvPr/>
                </p:nvSpPr>
                <p:spPr>
                  <a:xfrm>
                    <a:off x="563881" y="4730648"/>
                    <a:ext cx="93634" cy="6872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57" name="Rectangle 56"/>
                <p:cNvSpPr/>
                <p:nvPr/>
              </p:nvSpPr>
              <p:spPr>
                <a:xfrm>
                  <a:off x="592166" y="4114799"/>
                  <a:ext cx="45719" cy="1826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59" name="Rectangle 58"/>
              <p:cNvSpPr/>
              <p:nvPr/>
            </p:nvSpPr>
            <p:spPr>
              <a:xfrm>
                <a:off x="1447800" y="5543441"/>
                <a:ext cx="772247" cy="24775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5" name="Group 64"/>
            <p:cNvGrpSpPr/>
            <p:nvPr/>
          </p:nvGrpSpPr>
          <p:grpSpPr>
            <a:xfrm>
              <a:off x="4876800" y="1545440"/>
              <a:ext cx="838691" cy="1197760"/>
              <a:chOff x="4876800" y="1545440"/>
              <a:chExt cx="838691" cy="1197760"/>
            </a:xfrm>
            <a:solidFill>
              <a:schemeClr val="bg1"/>
            </a:solidFill>
          </p:grpSpPr>
          <p:sp>
            <p:nvSpPr>
              <p:cNvPr id="32" name="Rectangle 31"/>
              <p:cNvSpPr/>
              <p:nvPr/>
            </p:nvSpPr>
            <p:spPr>
              <a:xfrm>
                <a:off x="4876800" y="1783325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10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4876800" y="2021210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15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4876800" y="2259095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19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4876800" y="1545440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U-pBT-07</a:t>
                </a: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4876800" y="2496979"/>
                <a:ext cx="838691" cy="246221"/>
              </a:xfrm>
              <a:prstGeom prst="rect">
                <a:avLst/>
              </a:prstGeom>
              <a:grpFill/>
            </p:spPr>
            <p:txBody>
              <a:bodyPr wrap="none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U-pBT-28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25169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516791" y="87630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1" name="Rectangle 40"/>
          <p:cNvSpPr/>
          <p:nvPr/>
        </p:nvSpPr>
        <p:spPr>
          <a:xfrm>
            <a:off x="2426142" y="5531755"/>
            <a:ext cx="1534632" cy="27740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18 FDI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1899797" y="7213526"/>
            <a:ext cx="843403" cy="4873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sv-SE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sv-SE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DIR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16427" y="8768407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Fig. 4 </a:t>
            </a:r>
            <a:endParaRPr lang="en-US" dirty="0"/>
          </a:p>
        </p:txBody>
      </p:sp>
      <p:grpSp>
        <p:nvGrpSpPr>
          <p:cNvPr id="9" name="Group 8"/>
          <p:cNvGrpSpPr/>
          <p:nvPr/>
        </p:nvGrpSpPr>
        <p:grpSpPr>
          <a:xfrm>
            <a:off x="228600" y="152400"/>
            <a:ext cx="5141904" cy="7543800"/>
            <a:chOff x="228600" y="152400"/>
            <a:chExt cx="5141904" cy="7543800"/>
          </a:xfrm>
        </p:grpSpPr>
        <p:sp>
          <p:nvSpPr>
            <p:cNvPr id="27" name="TextBox 26"/>
            <p:cNvSpPr txBox="1"/>
            <p:nvPr/>
          </p:nvSpPr>
          <p:spPr>
            <a:xfrm>
              <a:off x="228600" y="304800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28600" y="548640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1002913" y="5354996"/>
              <a:ext cx="3873887" cy="2341204"/>
              <a:chOff x="914400" y="5354996"/>
              <a:chExt cx="3873887" cy="2341204"/>
            </a:xfrm>
          </p:grpSpPr>
          <p:pic>
            <p:nvPicPr>
              <p:cNvPr id="26" name="Picture 25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54284" y="7341861"/>
                <a:ext cx="190500" cy="1905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8" name="Rectangle 47"/>
              <p:cNvSpPr/>
              <p:nvPr/>
            </p:nvSpPr>
            <p:spPr>
              <a:xfrm flipH="1">
                <a:off x="1956629" y="6545590"/>
                <a:ext cx="294168" cy="3356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1787336" y="7239000"/>
                <a:ext cx="733896" cy="381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lnSpc>
                    <a:spcPct val="150000"/>
                  </a:lnSpc>
                </a:pPr>
                <a:r>
                  <a:rPr lang="sv-SE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 FDIR</a:t>
                </a:r>
              </a:p>
            </p:txBody>
          </p:sp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4400" y="5354996"/>
                <a:ext cx="3873887" cy="2257394"/>
              </a:xfrm>
              <a:prstGeom prst="rect">
                <a:avLst/>
              </a:prstGeom>
            </p:spPr>
          </p:pic>
          <p:sp>
            <p:nvSpPr>
              <p:cNvPr id="33" name="Rectangle 32"/>
              <p:cNvSpPr/>
              <p:nvPr/>
            </p:nvSpPr>
            <p:spPr>
              <a:xfrm>
                <a:off x="2667000" y="7208806"/>
                <a:ext cx="843403" cy="48739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lnSpc>
                    <a:spcPct val="150000"/>
                  </a:lnSpc>
                </a:pPr>
                <a:r>
                  <a:rPr lang="sv-SE" sz="12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+3 </a:t>
                </a:r>
                <a:r>
                  <a:rPr lang="sv-SE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DIR</a:t>
                </a:r>
              </a:p>
            </p:txBody>
          </p:sp>
        </p:grpSp>
        <p:pic>
          <p:nvPicPr>
            <p:cNvPr id="29" name="Content Placeholder 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19" t="28142" r="68597"/>
            <a:stretch/>
          </p:blipFill>
          <p:spPr>
            <a:xfrm>
              <a:off x="1394982" y="304800"/>
              <a:ext cx="1957818" cy="3173085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6293" y="2743200"/>
              <a:ext cx="3543307" cy="2223521"/>
            </a:xfrm>
            <a:prstGeom prst="rect">
              <a:avLst/>
            </a:prstGeom>
          </p:spPr>
        </p:pic>
        <p:sp>
          <p:nvSpPr>
            <p:cNvPr id="53" name="Rectangle 52"/>
            <p:cNvSpPr/>
            <p:nvPr/>
          </p:nvSpPr>
          <p:spPr>
            <a:xfrm>
              <a:off x="2103713" y="152400"/>
              <a:ext cx="593065" cy="5979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33"/>
            <p:cNvSpPr/>
            <p:nvPr/>
          </p:nvSpPr>
          <p:spPr>
            <a:xfrm>
              <a:off x="2769674" y="7208806"/>
              <a:ext cx="1161884" cy="4873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50000"/>
                </a:lnSpc>
              </a:pPr>
              <a:r>
                <a:rPr lang="sv-SE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+3 </a:t>
              </a:r>
              <a:r>
                <a:rPr lang="sv-SE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DIR</a:t>
              </a: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228600" y="297190"/>
              <a:ext cx="4644171" cy="2077336"/>
              <a:chOff x="228600" y="297190"/>
              <a:chExt cx="4644171" cy="2077336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228600" y="381000"/>
                <a:ext cx="3385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838200" y="297190"/>
                <a:ext cx="369332" cy="207733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milarity distance measure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2" name="Content Placeholder 11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992" r="-2383" b="66921"/>
              <a:stretch/>
            </p:blipFill>
            <p:spPr>
              <a:xfrm>
                <a:off x="3278188" y="533400"/>
                <a:ext cx="1217612" cy="573087"/>
              </a:xfrm>
              <a:prstGeom prst="rect">
                <a:avLst/>
              </a:prstGeom>
            </p:spPr>
          </p:pic>
          <p:sp>
            <p:nvSpPr>
              <p:cNvPr id="64" name="Rectangle 63"/>
              <p:cNvSpPr/>
              <p:nvPr/>
            </p:nvSpPr>
            <p:spPr>
              <a:xfrm>
                <a:off x="3278188" y="533400"/>
                <a:ext cx="1217612" cy="57308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1394982" y="2209800"/>
                <a:ext cx="258035" cy="1524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1676399" y="2209800"/>
                <a:ext cx="258035" cy="1524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2115856" y="2222126"/>
                <a:ext cx="258035" cy="152400"/>
              </a:xfrm>
              <a:prstGeom prst="rect">
                <a:avLst/>
              </a:prstGeom>
              <a:solidFill>
                <a:srgbClr val="CC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2445555" y="2222126"/>
                <a:ext cx="251223" cy="1524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rgbClr val="CCCCFF"/>
                </a:bgClr>
              </a:patt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49"/>
              <p:cNvSpPr/>
              <p:nvPr/>
            </p:nvSpPr>
            <p:spPr>
              <a:xfrm>
                <a:off x="2819400" y="2209800"/>
                <a:ext cx="258035" cy="152400"/>
              </a:xfrm>
              <a:prstGeom prst="rect">
                <a:avLst/>
              </a:prstGeom>
              <a:solidFill>
                <a:srgbClr val="CC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3149099" y="2209800"/>
                <a:ext cx="251223" cy="1524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rgbClr val="CCCCFF"/>
                </a:bgClr>
              </a:patt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Straight Connector 9"/>
              <p:cNvCxnSpPr/>
              <p:nvPr/>
            </p:nvCxnSpPr>
            <p:spPr>
              <a:xfrm>
                <a:off x="1653017" y="1371600"/>
                <a:ext cx="111356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Rectangle 35"/>
              <p:cNvSpPr/>
              <p:nvPr/>
            </p:nvSpPr>
            <p:spPr>
              <a:xfrm>
                <a:off x="4191000" y="1570951"/>
                <a:ext cx="161049" cy="76200"/>
              </a:xfrm>
              <a:prstGeom prst="rect">
                <a:avLst/>
              </a:prstGeom>
              <a:solidFill>
                <a:srgbClr val="CCCC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4193126" y="1743947"/>
                <a:ext cx="156797" cy="762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rgbClr val="CCCCFF"/>
                </a:bgClr>
              </a:patt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4191000" y="2075021"/>
                <a:ext cx="161049" cy="762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4191000" y="1916943"/>
                <a:ext cx="161049" cy="762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370710" y="1485940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    </a:t>
                </a:r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4370709" y="165877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4352049" y="182880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352049" y="1981200"/>
                <a:ext cx="4716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+3</a:t>
                </a:r>
                <a:endParaRPr lang="sv-S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Rectangle 10"/>
            <p:cNvSpPr/>
            <p:nvPr/>
          </p:nvSpPr>
          <p:spPr>
            <a:xfrm>
              <a:off x="4085535" y="1176138"/>
              <a:ext cx="115127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GU-pBT-07</a:t>
              </a:r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3988394" y="1478245"/>
              <a:ext cx="138211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sv-S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FDIR       </a:t>
              </a:r>
              <a:endParaRPr lang="sv-S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088701" y="160020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295400" y="180475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057400" y="168934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778850" y="496633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790827" y="496633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760491" y="496633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sv-S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90724" y="5335395"/>
              <a:ext cx="369332" cy="2177364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sv-S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v-S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v-S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MP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899896" y="3335793"/>
              <a:ext cx="369332" cy="1174360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thylation age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810000" y="5710535"/>
              <a:ext cx="131799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permethylated</a:t>
              </a:r>
            </a:p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omethylated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2374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116427" y="8768407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Fig. 5 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0" y="112307"/>
            <a:ext cx="6874565" cy="7815553"/>
            <a:chOff x="0" y="112307"/>
            <a:chExt cx="6874565" cy="7815553"/>
          </a:xfrm>
        </p:grpSpPr>
        <p:sp>
          <p:nvSpPr>
            <p:cNvPr id="21" name="Rectangle 20"/>
            <p:cNvSpPr/>
            <p:nvPr/>
          </p:nvSpPr>
          <p:spPr>
            <a:xfrm rot="16200000">
              <a:off x="-606089" y="1059153"/>
              <a:ext cx="1458401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pPr lvl="0"/>
              <a:r>
                <a:rPr lang="sv-S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sv-SE" sz="10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sv-S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ichment</a:t>
              </a:r>
              <a:endParaRPr lang="sv-S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12513" y="2480230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C</a:t>
              </a:r>
              <a:endParaRPr lang="en-GB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0" y="112307"/>
              <a:ext cx="4003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/>
                <a:t>A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971800" y="112307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 smtClean="0"/>
                <a:t>B</a:t>
              </a:r>
              <a:endParaRPr 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409710" y="2480230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 smtClean="0"/>
                <a:t>D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2513" y="5501128"/>
              <a:ext cx="3016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/>
                <a:t>E</a:t>
              </a:r>
              <a:endParaRPr lang="en-GB" dirty="0"/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968" y="5705377"/>
              <a:ext cx="3455767" cy="2158868"/>
            </a:xfrm>
            <a:prstGeom prst="rect">
              <a:avLst/>
            </a:prstGeom>
          </p:spPr>
        </p:pic>
        <p:pic>
          <p:nvPicPr>
            <p:cNvPr id="16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2301" y="5737110"/>
              <a:ext cx="2826388" cy="21907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3428099" y="5577328"/>
              <a:ext cx="3016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/>
                <a:t>F</a:t>
              </a:r>
              <a:endParaRPr lang="en-GB" dirty="0"/>
            </a:p>
          </p:txBody>
        </p:sp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85314" y="2749925"/>
              <a:ext cx="1804330" cy="2206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0"/>
            <a:stretch/>
          </p:blipFill>
          <p:spPr bwMode="auto">
            <a:xfrm>
              <a:off x="228600" y="270776"/>
              <a:ext cx="2730993" cy="20069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Rectangle 22"/>
            <p:cNvSpPr/>
            <p:nvPr/>
          </p:nvSpPr>
          <p:spPr>
            <a:xfrm rot="16200000">
              <a:off x="-529232" y="6340435"/>
              <a:ext cx="1549419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pPr lvl="0"/>
              <a:r>
                <a:rPr lang="sv-SE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sv-SE" sz="10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sv-S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ichment</a:t>
              </a:r>
              <a:endParaRPr lang="sv-S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/>
              <a:r>
                <a:rPr lang="sv-SE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P relative HM450K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61221" y="447329"/>
              <a:ext cx="3813344" cy="1968875"/>
            </a:xfrm>
            <a:prstGeom prst="rect">
              <a:avLst/>
            </a:prstGeom>
          </p:spPr>
        </p:pic>
        <p:sp>
          <p:nvSpPr>
            <p:cNvPr id="22" name="Rectangle 21"/>
            <p:cNvSpPr/>
            <p:nvPr/>
          </p:nvSpPr>
          <p:spPr>
            <a:xfrm rot="16200000">
              <a:off x="2365710" y="987091"/>
              <a:ext cx="1458401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pPr lvl="0"/>
              <a:r>
                <a:rPr lang="sv-SE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sv-SE" sz="10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sv-SE" sz="10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ichment</a:t>
              </a:r>
              <a:endParaRPr lang="sv-S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172337" y="2027804"/>
              <a:ext cx="85311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sv-S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Oval 25"/>
            <p:cNvSpPr/>
            <p:nvPr/>
          </p:nvSpPr>
          <p:spPr>
            <a:xfrm>
              <a:off x="2438400" y="5946660"/>
              <a:ext cx="45719" cy="7314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096" name="Group 4095"/>
            <p:cNvGrpSpPr/>
            <p:nvPr/>
          </p:nvGrpSpPr>
          <p:grpSpPr>
            <a:xfrm>
              <a:off x="123111" y="2403428"/>
              <a:ext cx="4154687" cy="3260227"/>
              <a:chOff x="123111" y="2403428"/>
              <a:chExt cx="4154687" cy="3260227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3111" y="2403428"/>
                <a:ext cx="4154687" cy="3260227"/>
              </a:xfrm>
              <a:prstGeom prst="rect">
                <a:avLst/>
              </a:prstGeom>
            </p:spPr>
          </p:pic>
          <p:cxnSp>
            <p:nvCxnSpPr>
              <p:cNvPr id="31" name="Straight Connector 30"/>
              <p:cNvCxnSpPr/>
              <p:nvPr/>
            </p:nvCxnSpPr>
            <p:spPr>
              <a:xfrm>
                <a:off x="2165708" y="4343400"/>
                <a:ext cx="1415692" cy="0"/>
              </a:xfrm>
              <a:prstGeom prst="line">
                <a:avLst/>
              </a:prstGeom>
              <a:ln w="762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4" name="Straight Connector 33"/>
            <p:cNvCxnSpPr/>
            <p:nvPr/>
          </p:nvCxnSpPr>
          <p:spPr>
            <a:xfrm>
              <a:off x="2165708" y="3429000"/>
              <a:ext cx="882292" cy="0"/>
            </a:xfrm>
            <a:prstGeom prst="line">
              <a:avLst/>
            </a:prstGeom>
            <a:ln w="762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288499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294294" y="3787798"/>
            <a:ext cx="623429" cy="2241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>
                <a:solidFill>
                  <a:schemeClr val="bg1"/>
                </a:solidFill>
              </a:rPr>
              <a:t>15 FDIR 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594831" y="3787798"/>
            <a:ext cx="596169" cy="685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6164" y="3753477"/>
            <a:ext cx="1828800" cy="13769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844" y="3753477"/>
            <a:ext cx="1828800" cy="13769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104551" y="429162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C</a:t>
            </a:r>
            <a:endParaRPr lang="en-US" dirty="0"/>
          </a:p>
        </p:txBody>
      </p:sp>
      <p:sp>
        <p:nvSpPr>
          <p:cNvPr id="76" name="TextBox 75"/>
          <p:cNvSpPr txBox="1"/>
          <p:nvPr/>
        </p:nvSpPr>
        <p:spPr>
          <a:xfrm>
            <a:off x="384446" y="6051832"/>
            <a:ext cx="671979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sv-SE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FDIR</a:t>
            </a:r>
            <a:endParaRPr lang="en-GB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Content Placeholder 3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5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91" t="24764" r="11451" b="21872"/>
          <a:stretch/>
        </p:blipFill>
        <p:spPr>
          <a:xfrm>
            <a:off x="4483483" y="5296557"/>
            <a:ext cx="1841117" cy="1371600"/>
          </a:xfrm>
          <a:prstGeom prst="rect">
            <a:avLst/>
          </a:prstGeom>
        </p:spPr>
      </p:pic>
      <p:pic>
        <p:nvPicPr>
          <p:cNvPr id="70" name="Content Placeholder 3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25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675" t="39311" r="52423" b="39242"/>
          <a:stretch/>
        </p:blipFill>
        <p:spPr>
          <a:xfrm rot="16200000">
            <a:off x="4715552" y="3501732"/>
            <a:ext cx="1376979" cy="1841116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129866" y="577031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D</a:t>
            </a:r>
            <a:endParaRPr lang="en-US" dirty="0"/>
          </a:p>
        </p:txBody>
      </p:sp>
      <p:pic>
        <p:nvPicPr>
          <p:cNvPr id="4" name="Picture 2"/>
          <p:cNvPicPr preferRelativeResize="0">
            <a:picLocks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331"/>
          <a:stretch/>
        </p:blipFill>
        <p:spPr bwMode="auto">
          <a:xfrm>
            <a:off x="508844" y="5296557"/>
            <a:ext cx="182880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7" name="Group 16"/>
          <p:cNvGrpSpPr/>
          <p:nvPr/>
        </p:nvGrpSpPr>
        <p:grpSpPr>
          <a:xfrm>
            <a:off x="134669" y="164604"/>
            <a:ext cx="6113731" cy="3120569"/>
            <a:chOff x="134669" y="164604"/>
            <a:chExt cx="6113731" cy="3120569"/>
          </a:xfrm>
        </p:grpSpPr>
        <p:sp>
          <p:nvSpPr>
            <p:cNvPr id="6" name="TextBox 5"/>
            <p:cNvSpPr txBox="1"/>
            <p:nvPr/>
          </p:nvSpPr>
          <p:spPr>
            <a:xfrm>
              <a:off x="134669" y="929560"/>
              <a:ext cx="269673" cy="298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A</a:t>
              </a:r>
              <a:endParaRPr lang="en-US" dirty="0"/>
            </a:p>
          </p:txBody>
        </p:sp>
        <p:pic>
          <p:nvPicPr>
            <p:cNvPr id="14" name="Picture 3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25000"/>
                      </a14:imgEffect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4686" y="393204"/>
              <a:ext cx="1828800" cy="137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6" descr="E:\Anna D\AD GUBT7 1638\190106\1till5\Mall GUpBT07p271638AD190106 1till5 cccc.tif"/>
            <p:cNvPicPr preferRelativeResize="0">
              <a:picLocks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513847" y="393204"/>
              <a:ext cx="182880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1021324" y="164604"/>
              <a:ext cx="671979" cy="276999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FDIR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953000" y="164604"/>
              <a:ext cx="931665" cy="276999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+3 FDIR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151247" y="164604"/>
              <a:ext cx="671979" cy="276999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sv-SE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sv-S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FDIR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6" name="Picture 2" descr="F:\obs nu\190411\BT7p29 1638 c.tif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45941" y="393204"/>
              <a:ext cx="1802459" cy="13518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8024" y="1893817"/>
              <a:ext cx="2168313" cy="1391356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03486" y="1757999"/>
              <a:ext cx="2374691" cy="1517083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134669" y="2338679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B</a:t>
              </a:r>
              <a:endParaRPr lang="en-US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3861048" y="3083475"/>
            <a:ext cx="55175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700" dirty="0" smtClean="0"/>
              <a:t>15+3 FDIR</a:t>
            </a:r>
            <a:endParaRPr lang="en-US" sz="700" dirty="0"/>
          </a:p>
        </p:txBody>
      </p:sp>
      <p:sp>
        <p:nvSpPr>
          <p:cNvPr id="29" name="TextBox 28"/>
          <p:cNvSpPr txBox="1"/>
          <p:nvPr/>
        </p:nvSpPr>
        <p:spPr>
          <a:xfrm>
            <a:off x="3386100" y="3083475"/>
            <a:ext cx="41710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700" dirty="0" smtClean="0"/>
              <a:t>3 FDIR</a:t>
            </a:r>
            <a:endParaRPr lang="en-US" sz="700" dirty="0"/>
          </a:p>
        </p:txBody>
      </p:sp>
      <p:sp>
        <p:nvSpPr>
          <p:cNvPr id="31" name="TextBox 30"/>
          <p:cNvSpPr txBox="1"/>
          <p:nvPr/>
        </p:nvSpPr>
        <p:spPr>
          <a:xfrm>
            <a:off x="2852700" y="3083475"/>
            <a:ext cx="41710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700" dirty="0" smtClean="0"/>
              <a:t>0 FDIR</a:t>
            </a:r>
            <a:endParaRPr lang="en-US" sz="700" dirty="0"/>
          </a:p>
        </p:txBody>
      </p:sp>
      <p:sp>
        <p:nvSpPr>
          <p:cNvPr id="46" name="TextBox 45"/>
          <p:cNvSpPr txBox="1"/>
          <p:nvPr/>
        </p:nvSpPr>
        <p:spPr>
          <a:xfrm>
            <a:off x="1734246" y="3088749"/>
            <a:ext cx="55175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700" dirty="0" smtClean="0"/>
              <a:t>15+3 FDIR</a:t>
            </a:r>
            <a:endParaRPr lang="en-US" sz="700" dirty="0"/>
          </a:p>
        </p:txBody>
      </p:sp>
      <p:sp>
        <p:nvSpPr>
          <p:cNvPr id="47" name="TextBox 46"/>
          <p:cNvSpPr txBox="1"/>
          <p:nvPr/>
        </p:nvSpPr>
        <p:spPr>
          <a:xfrm>
            <a:off x="1335498" y="3088749"/>
            <a:ext cx="41710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700" dirty="0" smtClean="0"/>
              <a:t>3 FDIR</a:t>
            </a:r>
            <a:endParaRPr lang="en-US" sz="700" dirty="0"/>
          </a:p>
        </p:txBody>
      </p:sp>
      <p:sp>
        <p:nvSpPr>
          <p:cNvPr id="48" name="TextBox 47"/>
          <p:cNvSpPr txBox="1"/>
          <p:nvPr/>
        </p:nvSpPr>
        <p:spPr>
          <a:xfrm>
            <a:off x="878298" y="3088749"/>
            <a:ext cx="41710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700" dirty="0" smtClean="0"/>
              <a:t>0 FDIR</a:t>
            </a:r>
            <a:endParaRPr lang="en-US" sz="700" dirty="0"/>
          </a:p>
        </p:txBody>
      </p:sp>
      <p:pic>
        <p:nvPicPr>
          <p:cNvPr id="16" name="Picture 15"/>
          <p:cNvPicPr preferRelativeResize="0"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05"/>
          <a:stretch/>
        </p:blipFill>
        <p:spPr>
          <a:xfrm>
            <a:off x="2511507" y="5296556"/>
            <a:ext cx="1813457" cy="137160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55417" y="8610600"/>
            <a:ext cx="7328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v-SE" dirty="0"/>
              <a:t>Fig. 6</a:t>
            </a:r>
            <a:r>
              <a:rPr lang="sv-SE" dirty="0" smtClean="0"/>
              <a:t> 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160324" y="728293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E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1004421" y="3441204"/>
            <a:ext cx="671979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 FDIR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851033" y="3441204"/>
            <a:ext cx="931665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+3 FDIR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990075" y="3441204"/>
            <a:ext cx="671979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sv-SE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sv-S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DIR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2" descr="E:\190109\Anna D\FIG 6\FIG6_190403 KB0017 BT7p15 rad2 gfap highlight OBS.png"/>
          <p:cNvPicPr>
            <a:picLocks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" t="56140" r="49981" b="14405"/>
          <a:stretch/>
        </p:blipFill>
        <p:spPr bwMode="auto">
          <a:xfrm>
            <a:off x="2502322" y="6858000"/>
            <a:ext cx="18288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2" descr="E:\190109\Anna D\FIG 6\AD190312_col_edudapigfap_ – Measurement1\FIG_6_AD190312_col_edudapigfap_ – Measurement1_c3.png"/>
          <p:cNvPicPr preferRelativeResize="0">
            <a:picLocks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91" t="19808" r="23405" b="14220"/>
          <a:stretch/>
        </p:blipFill>
        <p:spPr bwMode="auto">
          <a:xfrm>
            <a:off x="4495800" y="6858000"/>
            <a:ext cx="18288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2" name="Group 11"/>
          <p:cNvGrpSpPr/>
          <p:nvPr/>
        </p:nvGrpSpPr>
        <p:grpSpPr>
          <a:xfrm>
            <a:off x="508844" y="6858000"/>
            <a:ext cx="1828800" cy="1371600"/>
            <a:chOff x="508844" y="6858000"/>
            <a:chExt cx="1828800" cy="1371600"/>
          </a:xfrm>
        </p:grpSpPr>
        <p:pic>
          <p:nvPicPr>
            <p:cNvPr id="41" name="Picture 2" descr="E:\190109\Anna D\181_CT_190403 KB0018 BT7p15 ctr1 Measurement4\181_CT_190403 KB0018 BT7p15 ctr1 – Measurement4_GFAP weaker.png"/>
            <p:cNvPicPr>
              <a:picLocks noChangeAspect="1" noChangeArrowheads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33" t="13156" r="24868" b="34977"/>
            <a:stretch/>
          </p:blipFill>
          <p:spPr bwMode="auto">
            <a:xfrm>
              <a:off x="508844" y="6858000"/>
              <a:ext cx="1828800" cy="1371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3" name="Picture 2" descr="E:\190109\Anna D\FIG 6\FIG6_190403 KB0017 BT7p15 rad2 gfap highlight OBS.png"/>
            <p:cNvPicPr>
              <a:picLocks noChangeAspect="1"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60" t="93104" r="71933" b="5285"/>
            <a:stretch/>
          </p:blipFill>
          <p:spPr bwMode="auto">
            <a:xfrm>
              <a:off x="694460" y="8147885"/>
              <a:ext cx="829540" cy="753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44" name="TextBox 43"/>
          <p:cNvSpPr txBox="1"/>
          <p:nvPr/>
        </p:nvSpPr>
        <p:spPr>
          <a:xfrm>
            <a:off x="805373" y="3137356"/>
            <a:ext cx="510076" cy="215444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sv-S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FDIR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318724" y="3137356"/>
            <a:ext cx="510076" cy="215444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sv-S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sv-S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FDIR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753597" y="3137356"/>
            <a:ext cx="684803" cy="215444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sv-S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+3 FDIR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819400" y="3137356"/>
            <a:ext cx="510076" cy="215444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sv-S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 FDIR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376124" y="3137356"/>
            <a:ext cx="510076" cy="215444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sv-S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sv-S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FDIR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887197" y="3137356"/>
            <a:ext cx="684803" cy="215444"/>
          </a:xfrm>
          <a:prstGeom prst="rect">
            <a:avLst/>
          </a:prstGeom>
          <a:solidFill>
            <a:schemeClr val="bg1"/>
          </a:solidFill>
        </p:spPr>
        <p:txBody>
          <a:bodyPr vert="horz" wrap="none" rtlCol="0">
            <a:spAutoFit/>
          </a:bodyPr>
          <a:lstStyle/>
          <a:p>
            <a:r>
              <a:rPr lang="sv-S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+3 FDIR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 rot="16200000">
            <a:off x="92379" y="2388551"/>
            <a:ext cx="861133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iability (%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 rot="16200000">
            <a:off x="1864788" y="2326213"/>
            <a:ext cx="1241045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 diameter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53723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523</TotalTime>
  <Words>258</Words>
  <Application>Microsoft Office PowerPoint</Application>
  <PresentationFormat>On-screen Show (4:3)</PresentationFormat>
  <Paragraphs>140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Gothenburg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Danielsson</dc:creator>
  <cp:lastModifiedBy>Helena Carén</cp:lastModifiedBy>
  <cp:revision>339</cp:revision>
  <cp:lastPrinted>2019-08-26T13:01:29Z</cp:lastPrinted>
  <dcterms:created xsi:type="dcterms:W3CDTF">2019-04-15T14:28:54Z</dcterms:created>
  <dcterms:modified xsi:type="dcterms:W3CDTF">2020-02-06T15:36:06Z</dcterms:modified>
</cp:coreProperties>
</file>